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9" d="100"/>
          <a:sy n="89" d="100"/>
        </p:scale>
        <p:origin x="466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A6253-0871-4B2A-8645-D41F18546160}" type="datetimeFigureOut">
              <a:rPr lang="en-GB" smtClean="0"/>
              <a:t>22/1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620CB-22BE-4A00-AC83-7C1431E440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038669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A6253-0871-4B2A-8645-D41F18546160}" type="datetimeFigureOut">
              <a:rPr lang="en-GB" smtClean="0"/>
              <a:t>22/1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620CB-22BE-4A00-AC83-7C1431E440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694279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A6253-0871-4B2A-8645-D41F18546160}" type="datetimeFigureOut">
              <a:rPr lang="en-GB" smtClean="0"/>
              <a:t>22/1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620CB-22BE-4A00-AC83-7C1431E440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721043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A6253-0871-4B2A-8645-D41F18546160}" type="datetimeFigureOut">
              <a:rPr lang="en-GB" smtClean="0"/>
              <a:t>22/1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620CB-22BE-4A00-AC83-7C1431E440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371060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A6253-0871-4B2A-8645-D41F18546160}" type="datetimeFigureOut">
              <a:rPr lang="en-GB" smtClean="0"/>
              <a:t>22/1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620CB-22BE-4A00-AC83-7C1431E440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399080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A6253-0871-4B2A-8645-D41F18546160}" type="datetimeFigureOut">
              <a:rPr lang="en-GB" smtClean="0"/>
              <a:t>22/1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620CB-22BE-4A00-AC83-7C1431E440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238691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A6253-0871-4B2A-8645-D41F18546160}" type="datetimeFigureOut">
              <a:rPr lang="en-GB" smtClean="0"/>
              <a:t>22/12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620CB-22BE-4A00-AC83-7C1431E440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664231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A6253-0871-4B2A-8645-D41F18546160}" type="datetimeFigureOut">
              <a:rPr lang="en-GB" smtClean="0"/>
              <a:t>22/12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620CB-22BE-4A00-AC83-7C1431E440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815787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A6253-0871-4B2A-8645-D41F18546160}" type="datetimeFigureOut">
              <a:rPr lang="en-GB" smtClean="0"/>
              <a:t>22/12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620CB-22BE-4A00-AC83-7C1431E440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738370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A6253-0871-4B2A-8645-D41F18546160}" type="datetimeFigureOut">
              <a:rPr lang="en-GB" smtClean="0"/>
              <a:t>22/1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620CB-22BE-4A00-AC83-7C1431E440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454847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A6253-0871-4B2A-8645-D41F18546160}" type="datetimeFigureOut">
              <a:rPr lang="en-GB" smtClean="0"/>
              <a:t>22/1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620CB-22BE-4A00-AC83-7C1431E440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80483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AA6253-0871-4B2A-8645-D41F18546160}" type="datetimeFigureOut">
              <a:rPr lang="en-GB" smtClean="0"/>
              <a:t>22/1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B620CB-22BE-4A00-AC83-7C1431E440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86821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12686" y="916131"/>
            <a:ext cx="5344386" cy="5040000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2194845" y="1402810"/>
            <a:ext cx="3446830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GB" altLang="en-US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S8.  </a:t>
            </a:r>
            <a:r>
              <a:rPr kumimoji="0" lang="en-GB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F14-92-A2 </a:t>
            </a:r>
            <a:r>
              <a:rPr kumimoji="0" lang="en-GB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V-3 </a:t>
            </a:r>
            <a:r>
              <a:rPr lang="en-GB" sz="1400" dirty="0"/>
              <a:t>The s2m of the 3’UTR from MT585643 VF14-92-A2 secondary structure as </a:t>
            </a:r>
            <a:r>
              <a:rPr lang="en-GB" sz="1400" dirty="0" err="1"/>
              <a:t>RNAfold</a:t>
            </a:r>
            <a:r>
              <a:rPr lang="en-GB" sz="1400" dirty="0"/>
              <a:t> MFE of -42 kcal/mol</a:t>
            </a: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endParaRPr kumimoji="0" lang="en-GB" alt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6345989" y="3045125"/>
            <a:ext cx="28984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’UTR s2m RNA Secondary structure </a:t>
            </a:r>
            <a:endParaRPr lang="en-GB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711143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28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NICS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ula Lagan</dc:creator>
  <cp:lastModifiedBy>Paula Lagan</cp:lastModifiedBy>
  <cp:revision>5</cp:revision>
  <dcterms:created xsi:type="dcterms:W3CDTF">2020-06-13T20:14:19Z</dcterms:created>
  <dcterms:modified xsi:type="dcterms:W3CDTF">2020-12-22T20:51:02Z</dcterms:modified>
</cp:coreProperties>
</file>